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280" autoAdjust="0"/>
  </p:normalViewPr>
  <p:slideViewPr>
    <p:cSldViewPr snapToGrid="0">
      <p:cViewPr>
        <p:scale>
          <a:sx n="77" d="100"/>
          <a:sy n="77" d="100"/>
        </p:scale>
        <p:origin x="-1572" y="-9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55" d="100"/>
          <a:sy n="55" d="100"/>
        </p:scale>
        <p:origin x="2880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CA4FB3-205A-4E15-B411-D24382A3E2DA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49C90E-BD72-4CF8-8D9D-6A497A60E215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19839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0628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1872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1176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9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9979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6416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1318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0909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3654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1948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4682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6D589-E894-4A6E-BB68-E99FDD8ED819}" type="datetimeFigureOut">
              <a:rPr lang="es-ES" smtClean="0"/>
              <a:pPr/>
              <a:t>26/05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43AA-8842-4EFB-B59B-4F9A052E22D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5752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59834" y="0"/>
            <a:ext cx="3810772" cy="30531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27655" y="3188043"/>
            <a:ext cx="3064890" cy="2457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125363" y="6202849"/>
            <a:ext cx="3002692" cy="2405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CuadroTexto 10"/>
          <p:cNvSpPr txBox="1"/>
          <p:nvPr/>
        </p:nvSpPr>
        <p:spPr>
          <a:xfrm flipH="1">
            <a:off x="1165651" y="2591443"/>
            <a:ext cx="49921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≥ p75 	          132	   111      	               99	       87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	 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		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&lt; p75	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36                    26                        20                   1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10"/>
          <p:cNvSpPr txBox="1"/>
          <p:nvPr/>
        </p:nvSpPr>
        <p:spPr>
          <a:xfrm flipH="1">
            <a:off x="1127752" y="5414273"/>
            <a:ext cx="49921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≥ p75 	             132	       122		   119	            114        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		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&lt; p75	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36                       34                        29                     27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 flipH="1">
            <a:off x="1128789" y="8377708"/>
            <a:ext cx="53587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≥ p75                            132                      111                     98                      85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	 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		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CP1 &lt; p75	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36                       26                      20                      17  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3854477" y="328513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rgbClr val="C00000"/>
                </a:solidFill>
              </a:rPr>
              <a:t>MCP-1≥p75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3916262" y="1029710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2">
                    <a:lumMod val="50000"/>
                  </a:schemeClr>
                </a:solidFill>
              </a:rPr>
              <a:t>MCP-1&lt;p75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3953331" y="4270318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rgbClr val="C00000"/>
                </a:solidFill>
              </a:rPr>
              <a:t>MCP-1≥p75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4002760" y="4662596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2">
                    <a:lumMod val="50000"/>
                  </a:schemeClr>
                </a:solidFill>
              </a:rPr>
              <a:t>MCP-1&lt;p75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3916261" y="6469821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rgbClr val="C00000"/>
                </a:solidFill>
              </a:rPr>
              <a:t>MCP-1≥p75</a:t>
            </a:r>
            <a:endParaRPr lang="en-GB" sz="1100" dirty="0">
              <a:solidFill>
                <a:srgbClr val="C00000"/>
              </a:solidFill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4113971" y="7035094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solidFill>
                  <a:schemeClr val="bg2">
                    <a:lumMod val="50000"/>
                  </a:schemeClr>
                </a:solidFill>
              </a:rPr>
              <a:t>MCP-1&lt;p75</a:t>
            </a:r>
            <a:endParaRPr lang="en-GB" sz="11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8" name="CuadroTexto 10"/>
          <p:cNvSpPr txBox="1"/>
          <p:nvPr/>
        </p:nvSpPr>
        <p:spPr>
          <a:xfrm>
            <a:off x="2429212" y="396482"/>
            <a:ext cx="6527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p=0.009</a:t>
            </a:r>
            <a:endParaRPr lang="es-ES" sz="1100" dirty="0"/>
          </a:p>
        </p:txBody>
      </p:sp>
      <p:sp>
        <p:nvSpPr>
          <p:cNvPr id="19" name="CuadroTexto 10"/>
          <p:cNvSpPr txBox="1"/>
          <p:nvPr/>
        </p:nvSpPr>
        <p:spPr>
          <a:xfrm>
            <a:off x="2544542" y="3613358"/>
            <a:ext cx="5806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p=0.02</a:t>
            </a:r>
            <a:endParaRPr lang="es-ES" sz="1100" dirty="0"/>
          </a:p>
        </p:txBody>
      </p:sp>
      <p:sp>
        <p:nvSpPr>
          <p:cNvPr id="20" name="CuadroTexto 10"/>
          <p:cNvSpPr txBox="1"/>
          <p:nvPr/>
        </p:nvSpPr>
        <p:spPr>
          <a:xfrm>
            <a:off x="2631039" y="6517196"/>
            <a:ext cx="5806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/>
              <a:t>p=0.01</a:t>
            </a:r>
            <a:endParaRPr lang="es-ES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7</TotalTime>
  <Words>40</Words>
  <Application>Microsoft Office PowerPoint</Application>
  <PresentationFormat>Presentación en pantalla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ABEL</dc:creator>
  <cp:lastModifiedBy>GRAUPERA, ISABEL (IDIBAPS)</cp:lastModifiedBy>
  <cp:revision>46</cp:revision>
  <dcterms:created xsi:type="dcterms:W3CDTF">2016-05-20T19:46:03Z</dcterms:created>
  <dcterms:modified xsi:type="dcterms:W3CDTF">2016-05-26T14:33:25Z</dcterms:modified>
</cp:coreProperties>
</file>